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5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43">
            <a:extLst>
              <a:ext uri="{FF2B5EF4-FFF2-40B4-BE49-F238E27FC236}">
                <a16:creationId xmlns:a16="http://schemas.microsoft.com/office/drawing/2014/main" id="{584A84E7-E93D-4D9F-6A10-2317BB279F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3489" y="891945"/>
            <a:ext cx="5932026" cy="395191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1B4A25F-3C0D-7C1A-CB61-838D255E3329}"/>
              </a:ext>
            </a:extLst>
          </p:cNvPr>
          <p:cNvSpPr txBox="1"/>
          <p:nvPr/>
        </p:nvSpPr>
        <p:spPr>
          <a:xfrm rot="16200000">
            <a:off x="-825063" y="2419245"/>
            <a:ext cx="29232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ownregulated pathways with RER + RT vs RT alon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89362E1-4964-9A3C-EE1E-F0CC3B5D2702}"/>
              </a:ext>
            </a:extLst>
          </p:cNvPr>
          <p:cNvSpPr txBox="1"/>
          <p:nvPr/>
        </p:nvSpPr>
        <p:spPr>
          <a:xfrm>
            <a:off x="250268" y="5532475"/>
            <a:ext cx="6202680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gure S19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TGF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Symbol" pitchFamily="2" charset="2"/>
              </a:rPr>
              <a:t>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signaling is decreased in tumors of mice that receive RER following radiation therapy as compared to mice that are treated with radiation therapy (RT) alone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athway analysis performed on the significantly differentially downregulated genes in Ewing sarcoma tumors from mice treated with 5Gy RT and RER (TGF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inhibitor) compared to treatment with 5Gy RT and PBS control utilizing </a:t>
            </a:r>
            <a:r>
              <a:rPr lang="en-US" sz="11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EnrichR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sz="11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bioplanet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2019 library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887189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8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0:32Z</dcterms:modified>
</cp:coreProperties>
</file>